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58459-5620-4F50-AF81-EDC4EFAF87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C3E9D-0343-4731-A75F-8C1DE8501D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3D4FE-0261-43C8-9FAF-8AB0A18D34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E1C4AA-0B75-4443-91EB-30F61E06A1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CA316-5753-42C2-BF39-CB54ADE816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77878-1F27-40F7-94DA-FAA9936DC1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5424D-DC7A-418C-967B-5A917114BA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83980-978A-43BF-BCF3-5978F5C63C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6F8C8F-10AA-4F21-A00A-4E4747A55F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7443D-40FC-4357-A12C-2CFE80D5A5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273F1-E5B0-4DA5-865D-4FC9FFF231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D45F0-C885-4A7B-87AF-1746E0DE66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AC4968-1B0E-4A13-A21B-87B1AD48AEE7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1"/>
          <p:cNvSpPr/>
          <p:nvPr/>
        </p:nvSpPr>
        <p:spPr>
          <a:xfrm>
            <a:off x="679320" y="9612360"/>
            <a:ext cx="50770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. 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DFS rate (a) and OS rate (b) of in 75 ICC Patients after surgery between N0 and N1 patient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片 1" descr="g_name~ 93"/>
          <p:cNvPicPr/>
          <p:nvPr/>
        </p:nvPicPr>
        <p:blipFill>
          <a:blip r:embed="rId1"/>
          <a:stretch/>
        </p:blipFill>
        <p:spPr>
          <a:xfrm>
            <a:off x="915840" y="4626000"/>
            <a:ext cx="4270680" cy="34178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3" name=""/>
          <p:cNvGraphicFramePr/>
          <p:nvPr/>
        </p:nvGraphicFramePr>
        <p:xfrm>
          <a:off x="573120" y="3395520"/>
          <a:ext cx="4613400" cy="1349640"/>
        </p:xfrm>
        <a:graphic>
          <a:graphicData uri="http://schemas.openxmlformats.org/drawingml/2006/table">
            <a:tbl>
              <a:tblPr/>
              <a:tblGrid>
                <a:gridCol w="842760"/>
                <a:gridCol w="1262160"/>
                <a:gridCol w="843120"/>
                <a:gridCol w="806400"/>
                <a:gridCol w="858960"/>
              </a:tblGrid>
              <a:tr h="30492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 (45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2.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2.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6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49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 (33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 (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 (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573120" y="8116920"/>
          <a:ext cx="4613400" cy="1349280"/>
        </p:xfrm>
        <a:graphic>
          <a:graphicData uri="http://schemas.openxmlformats.org/drawingml/2006/table">
            <a:tbl>
              <a:tblPr/>
              <a:tblGrid>
                <a:gridCol w="842760"/>
                <a:gridCol w="1262160"/>
                <a:gridCol w="843120"/>
                <a:gridCol w="806400"/>
                <a:gridCol w="858960"/>
              </a:tblGrid>
              <a:tr h="30492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3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 (45.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2.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12.1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92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=19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(month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1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6 (34.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 (20.0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 (18.7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5" name="组合 4"/>
          <p:cNvGrpSpPr/>
          <p:nvPr/>
        </p:nvGrpSpPr>
        <p:grpSpPr>
          <a:xfrm>
            <a:off x="915840" y="25560"/>
            <a:ext cx="4270680" cy="3416040"/>
            <a:chOff x="915840" y="25560"/>
            <a:chExt cx="4270680" cy="3416040"/>
          </a:xfrm>
        </p:grpSpPr>
        <p:pic>
          <p:nvPicPr>
            <p:cNvPr id="46" name="图片 1" descr="g_name~ 141"/>
            <p:cNvPicPr/>
            <p:nvPr/>
          </p:nvPicPr>
          <p:blipFill>
            <a:blip r:embed="rId2"/>
            <a:stretch/>
          </p:blipFill>
          <p:spPr>
            <a:xfrm>
              <a:off x="915840" y="25560"/>
              <a:ext cx="4270680" cy="341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图片 1" descr="g_name~ 93"/>
            <p:cNvPicPr/>
            <p:nvPr/>
          </p:nvPicPr>
          <p:blipFill>
            <a:blip r:embed="rId3"/>
            <a:srcRect l="55437" t="9618" r="34372" b="82234"/>
            <a:stretch/>
          </p:blipFill>
          <p:spPr>
            <a:xfrm>
              <a:off x="3283200" y="270000"/>
              <a:ext cx="435240" cy="278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8-19T08:29:18Z</dcterms:created>
  <dc:creator>Administrator</dc:creator>
  <dc:description/>
  <dc:language>en-US</dc:language>
  <cp:lastModifiedBy>Jiu-Lin Song</cp:lastModifiedBy>
  <dcterms:modified xsi:type="dcterms:W3CDTF">2023-10-21T17:34:46Z</dcterms:modified>
  <cp:revision>5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69</vt:lpwstr>
  </property>
</Properties>
</file>